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 showGuides="1">
      <p:cViewPr varScale="1">
        <p:scale>
          <a:sx n="83" d="100"/>
          <a:sy n="83" d="100"/>
        </p:scale>
        <p:origin x="955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223950-4452-7D9C-1466-E0F61BBEF5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FC84A1D-6C2A-6A04-D295-450E1C1828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5181E1-CAEF-491E-36F2-ED113036E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6EC8B2-FC50-BE87-B626-F39D248AC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876C1E-D76C-DF87-F5BC-8262AE30F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7014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6A1FFD-28C3-607C-4DC1-39B835447C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C3402FE-0D61-2D10-09B1-CAA61F08D2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262D30-73D8-53F1-BA1A-55350CE4A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D6F365-2481-DA9C-110B-027B6F8E5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2A1AB40-2981-7E4E-3362-CC4F5D718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321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70647D1-ABBD-56B0-51ED-B7F32F3914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43072ED-110C-D445-A0ED-5E9609B00A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2F6C5E-49E2-131D-9D8B-35832D52C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DD8BDA-4E1A-E5FB-C1D3-34DB10379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13CD7F-A4DB-0DC6-E882-A79213B62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4649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247A28-A100-C218-133F-D03DF7B882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379E33-3CD6-897F-F8A1-1C50473DA9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65A405-969B-20B4-C258-6B900EA79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BDB085-BC34-7A94-676F-F7F9F11BFC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796FCC-C384-A5BB-23B9-977802193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3056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641370-3988-22D2-500E-14B211063A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6C473CC-0F5A-628B-133C-D613A84C2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11F827-6F42-4B35-E527-DD05B96A1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04D487-307C-FF0F-C374-C62FBA458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09373A-FC0F-F34C-3AFC-A34F2BADA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1790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3A7891-8BEB-AFF5-9ED1-A1B65951C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46F05D4-E374-4501-8041-F846751C97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B9E1B6A-A948-3C50-E904-70B845F8E3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CD8070-1200-6984-B0BF-A7411B50A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ABFE5F2-9C91-20DB-5148-991AB98B4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B74528A-2EB0-CDD2-D7B9-F954F2D10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9905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FA2A35-1D85-F721-9A2E-ACF1551C32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66C0B47-EEDB-FE1F-3213-9DAD614981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811DC5F-36AB-466E-CC5D-6F4A68B41E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DD88C1A-F14A-F3CB-84EE-ECCB0B97B2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9ACC8DB-DFBC-DD7E-625D-1AC419DFF6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2672708-84AD-D6AC-D75D-D9910D70C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90F8F56-1CF1-D190-9F7E-8B1F182C2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5D9ADA2-90C9-E392-4306-884550B9B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3340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F00BFB-231A-ED79-04AE-9B8D1F7549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13E7F49-05F6-9758-AAFD-54960732D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8C4C171-D99F-C5A4-4AE7-ED342E1E4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9A549A2-519C-3AB7-E9C9-051D0EF53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6032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094F167-BC4E-0A51-D949-1B2ACF7F0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EDB8F1F-8197-48D6-3530-E56E6B9FA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354C5DF-D67C-6EF3-40E3-259245034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9346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A6BC9C-0376-5BC6-64C2-67C2293C72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157E85-948B-4406-75AA-6F797FBD30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5EB99AF-F24F-1355-6AEE-DEC4057427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87EB39-16A0-4CDE-59A4-0E335492D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2D5654-A455-4BAD-7243-18F928B6D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82B33B7-A3EB-3DE0-2F1D-B304DF6DD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104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EA8655-256D-0DF8-EFF7-13CC3F0F42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110A8D4-D967-5CC2-AE57-B98A6C5BB3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091D21E-58AC-1E52-D96B-20AFB37602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FB719C0-E020-74FF-8D8A-DE8466005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4041FE-DF60-2A17-957E-20E68EC64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3740B87-704A-DE17-9E91-7C1472AF8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7754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4CDEF0E-76BF-B99C-CB6F-B38BFFCFB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8DAAE84-EC47-85C7-91F1-8BDE6DF30E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BC0E12-71FC-AF40-98F0-A5507FF761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D1A9B3-E46F-4594-9369-61545C80EA97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1BD882-5552-0399-0176-1C13B0AD29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3C2A78-7B2B-F474-C571-0F869170F5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85CD0-E65C-4053-97A1-3BC0E53298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2014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889B937-A691-93C5-F9DE-70C6CDBB67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8158" y="0"/>
            <a:ext cx="7795683" cy="632487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4E94DD04-8C68-1887-9EF8-E8E9378CBB2D}"/>
              </a:ext>
            </a:extLst>
          </p:cNvPr>
          <p:cNvSpPr txBox="1"/>
          <p:nvPr/>
        </p:nvSpPr>
        <p:spPr>
          <a:xfrm>
            <a:off x="-1669359" y="6239369"/>
            <a:ext cx="13800399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altLang="zh-CN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| The binding free energy of the MAPK3-estrone and MAPK3-17 beta estradiol complex. 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binding free energy of the MAPK3-estrone in 50–100 ns. 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four free energies and total binding free energy of the MAPK3-estrone in 50–100 ns. 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binding free energy of the MAPK3-17 beta estradiol complex in 50–100 ns. 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four free energies and total binding free energy of the MAPK3-17 beta estradiol complex in 50–100 ns.</a:t>
            </a:r>
            <a:endParaRPr lang="zh-CN" altLang="zh-CN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9338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Palatino Linotype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凌宇</dc:creator>
  <cp:lastModifiedBy>MDPI</cp:lastModifiedBy>
  <cp:revision>2</cp:revision>
  <dcterms:created xsi:type="dcterms:W3CDTF">2023-05-27T12:41:53Z</dcterms:created>
  <dcterms:modified xsi:type="dcterms:W3CDTF">2023-06-17T14:15:31Z</dcterms:modified>
</cp:coreProperties>
</file>